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9" r:id="rId4"/>
    <p:sldId id="258" r:id="rId5"/>
    <p:sldId id="260" r:id="rId6"/>
    <p:sldId id="261" r:id="rId7"/>
    <p:sldId id="266" r:id="rId8"/>
    <p:sldId id="262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8" userDrawn="1">
          <p15:clr>
            <a:srgbClr val="A4A3A4"/>
          </p15:clr>
        </p15:guide>
        <p15:guide id="2" pos="25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6405"/>
  </p:normalViewPr>
  <p:slideViewPr>
    <p:cSldViewPr snapToGrid="0" snapToObjects="1" showGuides="1">
      <p:cViewPr varScale="1">
        <p:scale>
          <a:sx n="98" d="100"/>
          <a:sy n="98" d="100"/>
        </p:scale>
        <p:origin x="3056" y="200"/>
      </p:cViewPr>
      <p:guideLst>
        <p:guide orient="horz" pos="528"/>
        <p:guide pos="25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908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5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035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669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980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532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516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520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929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08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081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1D861-79CF-A64F-89AF-2D5E1B2CCCAE}" type="datetimeFigureOut">
              <a:rPr lang="en-US" smtClean="0"/>
              <a:t>9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19C08-646C-8845-8FF3-C1A533B14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53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E5315901-0B9E-D14A-B962-D42134214C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98" y="76984"/>
            <a:ext cx="3349708" cy="285145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EA5842F-C197-1149-B03E-8780DDE65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1600" y="3268977"/>
            <a:ext cx="2379799" cy="264726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9154A9C-4FE3-954F-8920-A9972BD3F277}"/>
              </a:ext>
            </a:extLst>
          </p:cNvPr>
          <p:cNvSpPr txBox="1"/>
          <p:nvPr/>
        </p:nvSpPr>
        <p:spPr>
          <a:xfrm>
            <a:off x="176243" y="5916246"/>
            <a:ext cx="6468725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S1. (A) Genotyping gel showing mutant MyD88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loxed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 and wild-type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, and mutant FY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lele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Genotyping PCR was performed with MyD88 primers M-Myd88flox-fwd-GTT GTG TGT GTC CGA CCG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; -Myd88flox gen-rev-GTC AGA AAC AAC CAC CAC CAT GC, and FY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imers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w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AGG ATG TGA GGG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CT ACC TCC TGT A; rev—TCC TTC ACT CTG ATT CTG GCA ATT T).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 MyD88 mRNA expressi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Purified  CD4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FP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CD11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acrophages pooled spleen and CLN from thre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thre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ice were used for isolating RNA and MyD88 mRNA quantification by qPCR. Pool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s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om two independent experiments, EXPT1 and EXPT2 are shown. Primers used: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w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TAGGACAAACGCCGGAACT; rev-GAGAATCTGGCTCCGCATCA). Relative levels mRNA were assessed with value “1” assigned to naïve CD4+ T cells. WT spleen stimulated with LPS was used as a positive control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C) MyD88 expression in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ells were isolated from the CLN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ice as in Fig.1A. Flow cytometric plots showing CD4 and Foxp3 (above) expression on all leukocytes, and MyD88 expression (below) gated on Foxp3+ cells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1930456-48AE-394F-AC8D-00330B09E103}"/>
              </a:ext>
            </a:extLst>
          </p:cNvPr>
          <p:cNvSpPr txBox="1"/>
          <p:nvPr/>
        </p:nvSpPr>
        <p:spPr>
          <a:xfrm>
            <a:off x="1862780" y="3268977"/>
            <a:ext cx="277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D5A6E0DB-2EF8-4548-A45F-D261C4E87B42}"/>
              </a:ext>
            </a:extLst>
          </p:cNvPr>
          <p:cNvGrpSpPr/>
          <p:nvPr/>
        </p:nvGrpSpPr>
        <p:grpSpPr>
          <a:xfrm>
            <a:off x="3159326" y="247195"/>
            <a:ext cx="3694234" cy="2868154"/>
            <a:chOff x="3159326" y="247195"/>
            <a:chExt cx="3694234" cy="286815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7CFA604-CC05-154F-947C-DF87B2E50B94}"/>
                </a:ext>
              </a:extLst>
            </p:cNvPr>
            <p:cNvGrpSpPr/>
            <p:nvPr/>
          </p:nvGrpSpPr>
          <p:grpSpPr>
            <a:xfrm>
              <a:off x="3610930" y="247195"/>
              <a:ext cx="2985901" cy="2868154"/>
              <a:chOff x="3372595" y="1567047"/>
              <a:chExt cx="2985901" cy="286815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538D8D4-FFE2-E541-B672-E24FD868B1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2664" b="18046"/>
              <a:stretch/>
            </p:blipFill>
            <p:spPr>
              <a:xfrm>
                <a:off x="3372595" y="1588992"/>
                <a:ext cx="1965736" cy="1319994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E95EF3F-F540-6E46-BEF0-BAB5F4965F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54"/>
              <a:stretch/>
            </p:blipFill>
            <p:spPr>
              <a:xfrm>
                <a:off x="3429000" y="1567047"/>
                <a:ext cx="2929496" cy="2868154"/>
              </a:xfrm>
              <a:prstGeom prst="rect">
                <a:avLst/>
              </a:prstGeom>
            </p:spPr>
          </p:pic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DF54959-6687-5741-8304-3184B72597A9}"/>
                </a:ext>
              </a:extLst>
            </p:cNvPr>
            <p:cNvGrpSpPr/>
            <p:nvPr/>
          </p:nvGrpSpPr>
          <p:grpSpPr>
            <a:xfrm rot="1890821">
              <a:off x="3853578" y="1561325"/>
              <a:ext cx="279104" cy="194341"/>
              <a:chOff x="1307432" y="3880960"/>
              <a:chExt cx="192506" cy="179258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B48B4EF5-D0FF-B540-8C56-1379ABE70AA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07432" y="3880960"/>
                <a:ext cx="144379" cy="1231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0FBC6044-53E7-5842-A551-5F6612A8D3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55559" y="3937108"/>
                <a:ext cx="144379" cy="1231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5A711368-A069-754A-B62E-4C0960C2E381}"/>
                </a:ext>
              </a:extLst>
            </p:cNvPr>
            <p:cNvGrpSpPr/>
            <p:nvPr/>
          </p:nvGrpSpPr>
          <p:grpSpPr>
            <a:xfrm rot="1890821">
              <a:off x="4294598" y="1539918"/>
              <a:ext cx="279104" cy="194341"/>
              <a:chOff x="1307432" y="3880960"/>
              <a:chExt cx="192506" cy="179258"/>
            </a:xfrm>
          </p:grpSpPr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E6B64CA2-B5EB-564B-BE35-EF1744CDB2E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07432" y="3880960"/>
                <a:ext cx="144379" cy="1231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DF73E547-5395-314A-BB74-8ADF8234812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55559" y="3937108"/>
                <a:ext cx="144379" cy="1231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0779EAD-2BBF-DF45-AE8C-22A6C2FBDDF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08283" y="658204"/>
              <a:ext cx="208480" cy="164620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0F84DC9-2BF5-7F4F-96D5-8B81B297570A}"/>
                </a:ext>
              </a:extLst>
            </p:cNvPr>
            <p:cNvSpPr txBox="1"/>
            <p:nvPr/>
          </p:nvSpPr>
          <p:spPr>
            <a:xfrm>
              <a:off x="3159326" y="371473"/>
              <a:ext cx="2776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ADD46778-E1E1-4E46-AEC0-B4FCCE2810D9}"/>
                </a:ext>
              </a:extLst>
            </p:cNvPr>
            <p:cNvCxnSpPr/>
            <p:nvPr/>
          </p:nvCxnSpPr>
          <p:spPr>
            <a:xfrm>
              <a:off x="6303078" y="1204671"/>
              <a:ext cx="0" cy="276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C67A26AD-348D-334B-BDE4-6D7CF4A11EFE}"/>
                </a:ext>
              </a:extLst>
            </p:cNvPr>
            <p:cNvCxnSpPr/>
            <p:nvPr/>
          </p:nvCxnSpPr>
          <p:spPr>
            <a:xfrm>
              <a:off x="6308897" y="1614312"/>
              <a:ext cx="0" cy="2766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49CCCB5-B9D8-554C-BD76-716C3F1E4835}"/>
                </a:ext>
              </a:extLst>
            </p:cNvPr>
            <p:cNvSpPr txBox="1"/>
            <p:nvPr/>
          </p:nvSpPr>
          <p:spPr>
            <a:xfrm>
              <a:off x="6240437" y="1223918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XPT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00A927B-C642-2F4B-8992-9F743D8F98C8}"/>
                </a:ext>
              </a:extLst>
            </p:cNvPr>
            <p:cNvSpPr txBox="1"/>
            <p:nvPr/>
          </p:nvSpPr>
          <p:spPr>
            <a:xfrm>
              <a:off x="6255392" y="1616110"/>
              <a:ext cx="598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XPT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50719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58F5D85-FF53-2E40-B9C8-61390B6AB3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193" y="147174"/>
            <a:ext cx="6361611" cy="41243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8E1A42B-7510-D345-8090-22CC2953D0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1072" y="4362994"/>
            <a:ext cx="5969726" cy="4380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375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537BF1-2577-DD4B-85C8-D3283671EA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FE3FE7-370C-B242-88BB-A23A7FA649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F0C42ED-F980-F349-9DAB-B5038CE0EF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744" y="486836"/>
            <a:ext cx="6386512" cy="7843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6184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E300475-53A2-C542-B736-C0A71A6A25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043" y="442150"/>
            <a:ext cx="6411202" cy="7526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98705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5546C1F-7572-6145-8C6E-00F2ECDCD3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3755" y="306892"/>
            <a:ext cx="1451089" cy="255827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4B1A6B1-170B-144C-89B3-92D57746EF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2069" y="4402265"/>
            <a:ext cx="6348548" cy="124597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16C8C98-4CB8-F24D-A22C-E036A0F713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626" y="2850245"/>
            <a:ext cx="5494748" cy="153308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BC0A594-B64D-A948-8B5F-E95B99508149}"/>
              </a:ext>
            </a:extLst>
          </p:cNvPr>
          <p:cNvSpPr txBox="1"/>
          <p:nvPr/>
        </p:nvSpPr>
        <p:spPr>
          <a:xfrm>
            <a:off x="222069" y="75596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76ECE1F-4DB9-2A4B-A5A9-4803BF3660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73585" y="782265"/>
            <a:ext cx="1087570" cy="109728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EAC96D5-E616-B643-B080-321745DBE42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68160" y="782265"/>
            <a:ext cx="1087483" cy="109728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34DD550-5684-294B-A57A-7CCF10F208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74517" y="761632"/>
            <a:ext cx="1081096" cy="109728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922AB51-5760-F247-9143-8B3E7640F31E}"/>
              </a:ext>
            </a:extLst>
          </p:cNvPr>
          <p:cNvSpPr txBox="1"/>
          <p:nvPr/>
        </p:nvSpPr>
        <p:spPr>
          <a:xfrm>
            <a:off x="275583" y="27415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72C8D5B-8E9C-E14A-96EE-DCD2950181BE}"/>
              </a:ext>
            </a:extLst>
          </p:cNvPr>
          <p:cNvCxnSpPr>
            <a:cxnSpLocks/>
          </p:cNvCxnSpPr>
          <p:nvPr/>
        </p:nvCxnSpPr>
        <p:spPr>
          <a:xfrm flipV="1">
            <a:off x="2250474" y="846382"/>
            <a:ext cx="0" cy="4627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F7250905-8886-5D4A-8F92-BDDBAFC60F21}"/>
              </a:ext>
            </a:extLst>
          </p:cNvPr>
          <p:cNvSpPr txBox="1"/>
          <p:nvPr/>
        </p:nvSpPr>
        <p:spPr>
          <a:xfrm rot="16200000">
            <a:off x="1981009" y="1446413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E33BDF3D-D71E-4B4A-A4EE-BCB5AC86DE8C}"/>
              </a:ext>
            </a:extLst>
          </p:cNvPr>
          <p:cNvCxnSpPr>
            <a:cxnSpLocks/>
          </p:cNvCxnSpPr>
          <p:nvPr/>
        </p:nvCxnSpPr>
        <p:spPr>
          <a:xfrm>
            <a:off x="2658595" y="1970114"/>
            <a:ext cx="3197018" cy="38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70EDA413-9D15-4043-8803-590BF0C8B445}"/>
              </a:ext>
            </a:extLst>
          </p:cNvPr>
          <p:cNvSpPr txBox="1"/>
          <p:nvPr/>
        </p:nvSpPr>
        <p:spPr>
          <a:xfrm>
            <a:off x="2250474" y="1850818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1358122-4C90-734D-AACF-92F086F75DAF}"/>
              </a:ext>
            </a:extLst>
          </p:cNvPr>
          <p:cNvSpPr txBox="1"/>
          <p:nvPr/>
        </p:nvSpPr>
        <p:spPr>
          <a:xfrm>
            <a:off x="2519600" y="521752"/>
            <a:ext cx="34932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+CA             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+CA       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FYcr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+CA +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s</a:t>
            </a:r>
            <a:endParaRPr 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ECFD794-41CD-CB4C-8872-0A908DE7A86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0853" y="5900502"/>
            <a:ext cx="6045521" cy="19992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F659C9-8A9E-7B4D-9841-0C37DB975D56}"/>
              </a:ext>
            </a:extLst>
          </p:cNvPr>
          <p:cNvSpPr txBox="1"/>
          <p:nvPr/>
        </p:nvSpPr>
        <p:spPr>
          <a:xfrm>
            <a:off x="275583" y="7854898"/>
            <a:ext cx="615424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7. HKGT mediated T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7 induction is increased with IL-1</a:t>
            </a:r>
            <a:r>
              <a:rPr lang="en-US" sz="10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IL and CLN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were stimulated 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D3(1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, 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D28(2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in the presence of TGF-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 (5 ng/ml), heat killed</a:t>
            </a:r>
          </a:p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andida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albicans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CA) germ tube (HKGT) (1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l), or IL-1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or a combination of all of these. After 5 days,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were processed for flow cytometry assessment. Flow cytometry plots showing Foxp3 and IL-17A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ression (gated on CD3+CD4+ cells).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2147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BAD24A-BEC7-BE4B-8961-50F9DEEB29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224" y="420923"/>
            <a:ext cx="6103668" cy="24362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ABFAFEA-7625-1F4F-980D-CBD40CC90256}"/>
              </a:ext>
            </a:extLst>
          </p:cNvPr>
          <p:cNvSpPr txBox="1"/>
          <p:nvPr/>
        </p:nvSpPr>
        <p:spPr>
          <a:xfrm>
            <a:off x="312619" y="7485018"/>
            <a:ext cx="641910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9. IL-</a:t>
            </a:r>
            <a:r>
              <a:rPr lang="en-US" sz="10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does not cause nuclear NF- kB translocation in HKGT stimulated CD4+ T cells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in vitro.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ïve CD4+ and CD4+CD25+Treg cells were CFSE labelled and stimulated as above for 3 days without or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IL-1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ells wer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estimulate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10 ng/ml of IL-1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first three panels) or PMA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on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last panel) for 4 hours before fixation and staining for NF- kB-p65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spu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n slides for confocal analyses. PMA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on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was used as a positive control. Overlays are shown here. p65 translocation (red) in to nuclei (blue), when overlaid appear pink, and the CFSE (green) spots when overlaid appear white. 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156B58-96D6-1542-BA64-CBC2096A40F1}"/>
              </a:ext>
            </a:extLst>
          </p:cNvPr>
          <p:cNvSpPr txBox="1"/>
          <p:nvPr/>
        </p:nvSpPr>
        <p:spPr>
          <a:xfrm>
            <a:off x="568235" y="4411443"/>
            <a:ext cx="455240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x vivo         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im + HKGT        stim + HKGT           stim + HKGT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                          + IL-b (10ng/ml)       +PMA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ono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18ABF33-6AF8-5547-AB2A-51A1728337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198" y="4946463"/>
            <a:ext cx="3035865" cy="200353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7315681-B91C-574D-BFDA-12BC8E8D6D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88530" y="4875484"/>
            <a:ext cx="1756410" cy="194238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B17EF18-0C25-DA45-A3CD-B0BD6EB7053A}"/>
              </a:ext>
            </a:extLst>
          </p:cNvPr>
          <p:cNvSpPr txBox="1"/>
          <p:nvPr/>
        </p:nvSpPr>
        <p:spPr>
          <a:xfrm>
            <a:off x="489858" y="4003469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S9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42F3EFF5-63FC-2D43-B742-12DE5708597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25048" t="21371" r="33529" b="31141"/>
          <a:stretch/>
        </p:blipFill>
        <p:spPr>
          <a:xfrm>
            <a:off x="3428999" y="4962081"/>
            <a:ext cx="977547" cy="9687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5601516-6A27-5947-B6A3-B8FE273C4FB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16060" t="45716" r="31827" b="1488"/>
          <a:stretch/>
        </p:blipFill>
        <p:spPr>
          <a:xfrm>
            <a:off x="3428998" y="5953060"/>
            <a:ext cx="977547" cy="924089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A8E73C4-8667-8C41-8753-066389F02DF0}"/>
              </a:ext>
            </a:extLst>
          </p:cNvPr>
          <p:cNvCxnSpPr>
            <a:cxnSpLocks/>
          </p:cNvCxnSpPr>
          <p:nvPr/>
        </p:nvCxnSpPr>
        <p:spPr>
          <a:xfrm>
            <a:off x="4663440" y="4946463"/>
            <a:ext cx="0" cy="8987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F8C357E-9D75-2049-B47C-9882C62D753B}"/>
              </a:ext>
            </a:extLst>
          </p:cNvPr>
          <p:cNvCxnSpPr>
            <a:cxnSpLocks/>
          </p:cNvCxnSpPr>
          <p:nvPr/>
        </p:nvCxnSpPr>
        <p:spPr>
          <a:xfrm>
            <a:off x="4663440" y="5978361"/>
            <a:ext cx="0" cy="8987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05628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D7253E4-B84B-5F45-BB69-0B18A3B228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620" y="256999"/>
            <a:ext cx="6412123" cy="347661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7D5B719-D359-2747-97A6-F63EE988F4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620" y="4160499"/>
            <a:ext cx="6254978" cy="4539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93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173861-1704-DB45-8536-28816D730B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068" y="564993"/>
            <a:ext cx="6413863" cy="56380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5602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</TotalTime>
  <Words>505</Words>
  <Application>Microsoft Macintosh PowerPoint</Application>
  <PresentationFormat>On-screen Show (4:3)</PresentationFormat>
  <Paragraphs>2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3</cp:revision>
  <cp:lastPrinted>2020-09-25T18:16:27Z</cp:lastPrinted>
  <dcterms:created xsi:type="dcterms:W3CDTF">2020-09-22T22:04:52Z</dcterms:created>
  <dcterms:modified xsi:type="dcterms:W3CDTF">2020-09-25T18:22:58Z</dcterms:modified>
</cp:coreProperties>
</file>